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7" d="100"/>
          <a:sy n="77" d="100"/>
        </p:scale>
        <p:origin x="384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81E5B-F0BD-4F76-BEBB-B20B7D942E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EBAFB8-7D37-43BB-A584-2FDC7D1196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B0980B-06F5-406C-8B13-0801F0EB7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0EF04-E48E-4B04-9717-19ABC4192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1BADB2-C453-472D-B070-53EFD1745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72109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A7A509-E8ED-4B2A-B97B-A6C1A76988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0CB22C-2053-4EB6-852F-9EFB2E1BA4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D8EA4F-135A-433B-A74A-3AEF0A61F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CF7218-D3C9-45B1-83FB-6B7E1F3C0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22F64A-4F01-420F-9CE2-27864C237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95807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4365E2-0835-4DCE-B797-B08B991888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67BA40-14AC-42D9-82CF-6D62C8D28C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74AA4F-FA0C-42F9-A4D7-E50DE27DC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7D828-FE4A-4024-A0A4-AC82CE094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DCF4CB-4C64-4C0D-8EEF-BCBD00B3D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6785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C4788-421A-4633-938B-06E5A33E8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2F28BA-004E-414E-B869-1899E4B725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C5870-F6C2-4ECA-A2D0-CDC15D99C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897F4-515C-4225-AB09-6FB1B244D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7E91B3-B9CB-477F-8B12-9C9734F49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25443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2589E-7440-4043-9AB4-106FD66CC3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4471F7-B5BF-4353-891D-42739ACC53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ED1FB7-8D9B-45A1-9A16-142863A22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CEB387-6BD4-4638-9CF1-9E7856E80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57555F-528C-4AE7-AF22-AEAACB974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42939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59CE8-D142-464D-9358-C44713EF41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171758-3784-4EAB-89A9-E2E8EBB2DE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19F8D4-6901-407B-8306-C8393CE139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34F10F-5E66-4C18-8A9C-1E1160FA4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991F6B-42AB-45FA-B684-227A15544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5DD555-B105-4D5B-8AFC-AFDCB2195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23558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6725F-0349-498A-B7D2-4D5C99BD68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56B4DC-84CE-47D2-8241-784DF7D0F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4BE2F5-F6DB-4F58-87A8-B67B12BA3C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AFC418-F629-4472-814C-D4118B2438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555444-DA64-4107-A28C-C829267775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A07998-2B5A-4182-942B-2C9C955FD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B0FB93-0994-402D-AA5C-0EBD27823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B2EF89-4225-44F6-A0C2-71B78EA13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897908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F821F7-77A1-44BE-A95F-7B28A7C12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3BA2D6-94AA-4C2C-A668-A972F36F4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D87BC0-01BA-4CB3-B43C-1B5162E4C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502463-DE4D-406B-A7AB-7A7F1D8CD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46099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AFE845-AD40-4D54-BE3C-254CB547F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8325B2-50F9-4E4C-A873-769D3C64D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E1F6DC-E27F-4C7F-BAC7-22AD56920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25472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9C5D9-867E-45F0-BA18-D507E8825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7255E-B7FC-4F8E-834B-9806CBABFF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40DD4F-3F74-472E-B05E-04A194DBC7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74F272-10CF-423C-BF37-E8EE1D34A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7501A6-BE55-4430-A2C0-815300A0D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AF9254-1745-4E3E-A729-BAA789306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791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FF86C-2D37-48B2-B70C-CA7712171A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BAB527-1A43-4BC9-8EF0-B8D1779054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51F928-2A4D-465D-8742-C65C767BE1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82C193-51F8-4453-83D9-7C7912089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841B43-2733-4FA1-B084-D89425913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29A4D7-BAE6-4FDA-8906-815B7AA64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8096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598C95-C0B4-4EEB-A37D-CF5A7138B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99A721-09D1-48EC-9EBE-04B0CC0EDA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6271C4-FE34-4DF3-99AB-63C36B6F00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42A9D-7C51-40A5-86F1-7133768ED0F6}" type="datetimeFigureOut">
              <a:rPr lang="en-DE" smtClean="0"/>
              <a:t>26/06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03F88-1DAF-4705-96B6-3426CC92E3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D340D6-23D5-45F5-ADB7-38E3ECB596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CC115-4560-4161-B74C-311FD90B897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14448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3">
            <a:extLst>
              <a:ext uri="{FF2B5EF4-FFF2-40B4-BE49-F238E27FC236}">
                <a16:creationId xmlns:a16="http://schemas.microsoft.com/office/drawing/2014/main" id="{1E638C5E-6060-4AAE-83BF-AF0838A0C7F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89" t="-764" r="-328" b="-815"/>
          <a:stretch/>
        </p:blipFill>
        <p:spPr>
          <a:xfrm rot="16200000">
            <a:off x="2012676" y="1257298"/>
            <a:ext cx="6062869" cy="45819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1405942-9ABF-410E-B227-20D08E76CED7}"/>
              </a:ext>
            </a:extLst>
          </p:cNvPr>
          <p:cNvSpPr/>
          <p:nvPr/>
        </p:nvSpPr>
        <p:spPr>
          <a:xfrm>
            <a:off x="5122094" y="1399691"/>
            <a:ext cx="1947811" cy="240699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FF74A0-C967-41C4-A27B-54A55CBC6C1D}"/>
              </a:ext>
            </a:extLst>
          </p:cNvPr>
          <p:cNvSpPr txBox="1"/>
          <p:nvPr/>
        </p:nvSpPr>
        <p:spPr>
          <a:xfrm>
            <a:off x="5307496" y="1028633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.</a:t>
            </a:r>
            <a:endParaRPr lang="en-DE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12ED384-D376-466E-892F-80E1B53319F5}"/>
              </a:ext>
            </a:extLst>
          </p:cNvPr>
          <p:cNvSpPr txBox="1"/>
          <p:nvPr/>
        </p:nvSpPr>
        <p:spPr>
          <a:xfrm>
            <a:off x="6070026" y="1028494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r>
              <a:rPr lang="en-US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KO</a:t>
            </a:r>
            <a:endParaRPr lang="en-DE" baseline="3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B6442534-25CD-4A0D-8A33-F8BE0BD0ED58}"/>
              </a:ext>
            </a:extLst>
          </p:cNvPr>
          <p:cNvCxnSpPr/>
          <p:nvPr/>
        </p:nvCxnSpPr>
        <p:spPr>
          <a:xfrm>
            <a:off x="5307496" y="1028494"/>
            <a:ext cx="1669774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94072FC4-F2B3-4DD2-ACCB-D3A264DBF9EB}"/>
              </a:ext>
            </a:extLst>
          </p:cNvPr>
          <p:cNvSpPr txBox="1"/>
          <p:nvPr/>
        </p:nvSpPr>
        <p:spPr>
          <a:xfrm>
            <a:off x="5602999" y="65823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5-50</a:t>
            </a:r>
            <a:endParaRPr lang="en-DE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743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45FBD9-CE4E-4E5B-AA61-A85E82E669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24366" y="1242486"/>
            <a:ext cx="6214533" cy="46609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18F341E-8C3A-4F82-981F-D920007118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820834" y="1242486"/>
            <a:ext cx="6214533" cy="46609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D3E1B4B-A5CB-47E5-A8A2-E4EB92DE5430}"/>
              </a:ext>
            </a:extLst>
          </p:cNvPr>
          <p:cNvSpPr/>
          <p:nvPr/>
        </p:nvSpPr>
        <p:spPr>
          <a:xfrm>
            <a:off x="3556000" y="1329267"/>
            <a:ext cx="1159933" cy="237913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6811501-8E00-4D31-9B55-712B5EBA8897}"/>
              </a:ext>
            </a:extLst>
          </p:cNvPr>
          <p:cNvSpPr/>
          <p:nvPr/>
        </p:nvSpPr>
        <p:spPr>
          <a:xfrm>
            <a:off x="7874000" y="922867"/>
            <a:ext cx="1159933" cy="237913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84C5FCB-DE09-42A8-B873-412FE54B5257}"/>
              </a:ext>
            </a:extLst>
          </p:cNvPr>
          <p:cNvSpPr/>
          <p:nvPr/>
        </p:nvSpPr>
        <p:spPr>
          <a:xfrm>
            <a:off x="2252133" y="1329267"/>
            <a:ext cx="1159933" cy="22690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5552A03-1A35-4959-B234-14FD6A541D78}"/>
              </a:ext>
            </a:extLst>
          </p:cNvPr>
          <p:cNvSpPr/>
          <p:nvPr/>
        </p:nvSpPr>
        <p:spPr>
          <a:xfrm>
            <a:off x="9150350" y="990599"/>
            <a:ext cx="1159933" cy="23791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5A8D28-084A-4C2A-86BC-7F0D5110E570}"/>
              </a:ext>
            </a:extLst>
          </p:cNvPr>
          <p:cNvSpPr txBox="1"/>
          <p:nvPr/>
        </p:nvSpPr>
        <p:spPr>
          <a:xfrm>
            <a:off x="4428970" y="806047"/>
            <a:ext cx="8067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P45-50</a:t>
            </a:r>
          </a:p>
          <a:p>
            <a:r>
              <a:rPr lang="en-US" sz="1400" dirty="0">
                <a:solidFill>
                  <a:srgbClr val="FF0000"/>
                </a:solidFill>
              </a:rPr>
              <a:t>Zbp1</a:t>
            </a:r>
            <a:r>
              <a:rPr lang="en-US" sz="1400" baseline="30000" dirty="0">
                <a:solidFill>
                  <a:srgbClr val="FF0000"/>
                </a:solidFill>
              </a:rPr>
              <a:t>WT/S</a:t>
            </a:r>
            <a:endParaRPr lang="en-DE" sz="1400" baseline="30000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297E2A3-FEF6-4E80-9105-F9EE897724A4}"/>
              </a:ext>
            </a:extLst>
          </p:cNvPr>
          <p:cNvSpPr txBox="1"/>
          <p:nvPr/>
        </p:nvSpPr>
        <p:spPr>
          <a:xfrm>
            <a:off x="1906839" y="641403"/>
            <a:ext cx="79778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P45-50</a:t>
            </a:r>
          </a:p>
          <a:p>
            <a:r>
              <a:rPr lang="en-US" sz="1400" dirty="0">
                <a:solidFill>
                  <a:srgbClr val="FF0000"/>
                </a:solidFill>
              </a:rPr>
              <a:t>RIPK1</a:t>
            </a:r>
            <a:r>
              <a:rPr lang="en-US" sz="1400" baseline="30000" dirty="0">
                <a:solidFill>
                  <a:srgbClr val="FF0000"/>
                </a:solidFill>
              </a:rPr>
              <a:t>EKO</a:t>
            </a:r>
          </a:p>
          <a:p>
            <a:r>
              <a:rPr lang="en-US" sz="1400" dirty="0">
                <a:solidFill>
                  <a:srgbClr val="FF0000"/>
                </a:solidFill>
              </a:rPr>
              <a:t>Zbp1</a:t>
            </a:r>
            <a:r>
              <a:rPr lang="en-US" sz="1400" baseline="30000" dirty="0">
                <a:solidFill>
                  <a:srgbClr val="FF0000"/>
                </a:solidFill>
              </a:rPr>
              <a:t>S/S</a:t>
            </a:r>
            <a:endParaRPr lang="en-DE" sz="1400" baseline="30000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A09A84-ED55-4000-9C3A-2099C5CDD1F4}"/>
              </a:ext>
            </a:extLst>
          </p:cNvPr>
          <p:cNvSpPr txBox="1"/>
          <p:nvPr/>
        </p:nvSpPr>
        <p:spPr>
          <a:xfrm>
            <a:off x="10285161" y="806047"/>
            <a:ext cx="80675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P45-50</a:t>
            </a:r>
          </a:p>
          <a:p>
            <a:r>
              <a:rPr lang="en-US" sz="1400" dirty="0">
                <a:solidFill>
                  <a:srgbClr val="FF0000"/>
                </a:solidFill>
              </a:rPr>
              <a:t>RIPK1</a:t>
            </a:r>
            <a:r>
              <a:rPr lang="en-US" sz="1400" baseline="30000" dirty="0">
                <a:solidFill>
                  <a:srgbClr val="FF0000"/>
                </a:solidFill>
              </a:rPr>
              <a:t>EKO</a:t>
            </a:r>
          </a:p>
          <a:p>
            <a:r>
              <a:rPr lang="en-US" sz="1400" dirty="0">
                <a:solidFill>
                  <a:srgbClr val="FF0000"/>
                </a:solidFill>
              </a:rPr>
              <a:t>Zbp1</a:t>
            </a:r>
            <a:r>
              <a:rPr lang="en-US" sz="1400" baseline="30000" dirty="0">
                <a:solidFill>
                  <a:srgbClr val="FF0000"/>
                </a:solidFill>
              </a:rPr>
              <a:t>WT/S</a:t>
            </a:r>
            <a:endParaRPr lang="en-DE" sz="1400" baseline="30000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F48EA6-1326-4450-AA2B-6A4284AEACC2}"/>
              </a:ext>
            </a:extLst>
          </p:cNvPr>
          <p:cNvSpPr txBox="1"/>
          <p:nvPr/>
        </p:nvSpPr>
        <p:spPr>
          <a:xfrm>
            <a:off x="7204510" y="749125"/>
            <a:ext cx="7040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P45-50</a:t>
            </a:r>
          </a:p>
          <a:p>
            <a:r>
              <a:rPr lang="en-US" sz="1400" dirty="0">
                <a:solidFill>
                  <a:srgbClr val="FF0000"/>
                </a:solidFill>
              </a:rPr>
              <a:t>Zbp1</a:t>
            </a:r>
            <a:r>
              <a:rPr lang="en-US" sz="1400" baseline="30000" dirty="0">
                <a:solidFill>
                  <a:srgbClr val="FF0000"/>
                </a:solidFill>
              </a:rPr>
              <a:t>S/S</a:t>
            </a:r>
            <a:endParaRPr lang="en-DE" sz="1400" baseline="300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69005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AA0D9BF-47B1-4CFC-A4C3-3148CC639B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1383" y="1028700"/>
            <a:ext cx="6400800" cy="48006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2819F99-843D-46F5-9C2B-698D14C8DD13}"/>
              </a:ext>
            </a:extLst>
          </p:cNvPr>
          <p:cNvSpPr/>
          <p:nvPr/>
        </p:nvSpPr>
        <p:spPr>
          <a:xfrm>
            <a:off x="2209800" y="1473200"/>
            <a:ext cx="1090079" cy="214206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6528FF3-69F2-4BDE-8326-532C9CC6EB1B}"/>
              </a:ext>
            </a:extLst>
          </p:cNvPr>
          <p:cNvSpPr/>
          <p:nvPr/>
        </p:nvSpPr>
        <p:spPr>
          <a:xfrm>
            <a:off x="3471337" y="1464733"/>
            <a:ext cx="1090079" cy="215053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BDE973-A951-4E55-8E54-DD6DA19D7C3B}"/>
              </a:ext>
            </a:extLst>
          </p:cNvPr>
          <p:cNvSpPr txBox="1"/>
          <p:nvPr/>
        </p:nvSpPr>
        <p:spPr>
          <a:xfrm>
            <a:off x="1396506" y="1095401"/>
            <a:ext cx="86427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16 weeks</a:t>
            </a:r>
          </a:p>
          <a:p>
            <a:r>
              <a:rPr lang="en-US" sz="1400" dirty="0">
                <a:solidFill>
                  <a:srgbClr val="FF0000"/>
                </a:solidFill>
              </a:rPr>
              <a:t>RIPK1</a:t>
            </a:r>
            <a:r>
              <a:rPr lang="en-US" sz="1400" baseline="30000" dirty="0">
                <a:solidFill>
                  <a:srgbClr val="FF0000"/>
                </a:solidFill>
              </a:rPr>
              <a:t>EKO</a:t>
            </a:r>
          </a:p>
          <a:p>
            <a:r>
              <a:rPr lang="en-US" sz="1400" dirty="0">
                <a:solidFill>
                  <a:srgbClr val="FF0000"/>
                </a:solidFill>
              </a:rPr>
              <a:t>Zbp1</a:t>
            </a:r>
            <a:r>
              <a:rPr lang="en-US" sz="1400" baseline="30000" dirty="0">
                <a:solidFill>
                  <a:srgbClr val="FF0000"/>
                </a:solidFill>
              </a:rPr>
              <a:t>WT/S</a:t>
            </a:r>
            <a:endParaRPr lang="en-DE" sz="1400" baseline="30000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DCA82D-BBDA-421E-8263-EA7CD7870869}"/>
              </a:ext>
            </a:extLst>
          </p:cNvPr>
          <p:cNvSpPr txBox="1"/>
          <p:nvPr/>
        </p:nvSpPr>
        <p:spPr>
          <a:xfrm>
            <a:off x="4374118" y="1016000"/>
            <a:ext cx="8642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16 weeks</a:t>
            </a:r>
          </a:p>
          <a:p>
            <a:r>
              <a:rPr lang="en-US" sz="1400" dirty="0">
                <a:solidFill>
                  <a:srgbClr val="FF0000"/>
                </a:solidFill>
              </a:rPr>
              <a:t>Zbp1</a:t>
            </a:r>
            <a:r>
              <a:rPr lang="en-US" sz="1400" baseline="30000" dirty="0">
                <a:solidFill>
                  <a:srgbClr val="FF0000"/>
                </a:solidFill>
              </a:rPr>
              <a:t>WT/S</a:t>
            </a:r>
            <a:endParaRPr lang="en-DE" sz="1400" baseline="300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3282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nagata</dc:creator>
  <cp:lastModifiedBy>mnagata</cp:lastModifiedBy>
  <cp:revision>6</cp:revision>
  <dcterms:created xsi:type="dcterms:W3CDTF">2024-06-06T15:19:23Z</dcterms:created>
  <dcterms:modified xsi:type="dcterms:W3CDTF">2024-06-26T18:07:21Z</dcterms:modified>
</cp:coreProperties>
</file>